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25" autoAdjust="0"/>
    <p:restoredTop sz="94660"/>
  </p:normalViewPr>
  <p:slideViewPr>
    <p:cSldViewPr snapToGrid="0">
      <p:cViewPr varScale="1">
        <p:scale>
          <a:sx n="90" d="100"/>
          <a:sy n="90" d="100"/>
        </p:scale>
        <p:origin x="85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50982F-204C-4B82-8ED5-1E6C9D5D409F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2EF224-D8E7-43D5-9A3C-2D9D27EB05D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8222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2EF224-D8E7-43D5-9A3C-2D9D27EB05DB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775072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F65DD53-CDAB-DFEC-C2F2-B0B2B64F84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EBAE0CB-6F8B-51AF-7752-F3E13B9AC1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A91EB27-3D8E-F0B0-EF79-796D07C92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10238AB-1676-A21D-1351-7FBEF589C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038DB3E-AEF6-CF0B-30C4-53F9F1F2F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2514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26589C9-64E3-FDBC-F42F-01878DA75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4232807-2D26-F1D5-B3D7-C64ED7BE85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3B25CBC-44E9-865A-BBDE-6B91E1518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021E336-FABA-82E4-861F-C4F46FDF8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5F1DB6B-2FF2-766C-A2AE-2F8897281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5950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FAB38C3-C707-FBB1-526A-85908B1211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A1BCC32-F53F-D3B4-2A41-0A139F7769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E28D2F1-FEEE-92FC-92EA-44E183BB8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1649CA9-1B57-6C89-CDBC-52C6DC82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6B84232-E245-E8D9-BB18-F92A6867C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9507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19D852C-CF82-3C41-13D5-EC3ED4AD2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E5B3455-AA4D-28ED-8001-6BD6A40360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FA78334-8ED9-9C03-2315-8F6A6D8B6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C4B2E12-AD40-6A08-0F81-546BE0A28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806EA25-A995-57CE-63DB-446327DC0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6165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D6D3DC0-4179-57F9-B6C3-D8C794663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D387DC5-4EAD-F807-5F99-9A1458F096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5290D7A-0BB8-8D6A-DD4E-280551C29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5CFE6DD-CEA7-4449-DAC8-C9A48E209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C8421FC-98DE-6087-E6FD-E4F6D2E23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586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BB99936-AD92-30DF-63D8-5B9330179D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73CBD58-8A14-4569-A77F-EC7D5FB463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DABFD31-0FA0-E124-00A3-25BE949D94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CC51CAF-AA02-0573-E5FE-A42634B04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FCB5D29-66D4-944D-A077-E4CC0A012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F1EEDF6-4A89-FA71-A6D9-545275502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300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8F743EF-AD11-E965-4A51-84D18380B2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7F6BAD0-86D7-8E2C-189E-01519ACBEE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24D22F7-23E5-6677-6837-8064C0AC07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BD862A9-5E42-B75D-3298-5C8434CEB1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09AC692-0149-FE8D-BC35-6F502C6527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EC9F454-5E11-7013-E7BB-CFDC18CFE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EC65A78-C8D1-216D-02D9-1CCF8C774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0DE1BDA-4872-5497-9A75-4EA62A5E7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8891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93D5B2C-9DA7-6FDA-C4DA-36F3EA9E8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DDC7169-504A-50F9-C9ED-42E069186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51E9044-61BF-F21B-D2AF-C1E377CF4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F1C0FF2-BE4E-1AB8-EC16-C9804B5BC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030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1ED815E-35A9-C2B6-B3FD-80BCB0715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94EA77A-4AC5-1B66-1A5D-67E07C31F3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6C931BE-9A4F-F2A9-B23D-11F1E1872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980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9B29488-8EEC-B99C-0CDC-F51B1A7ECF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586D74B-7847-30FE-4B1C-7863BBD0AE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D3ADC3D-A02E-4ADA-CB88-CEE88FE875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C4DB7B6-F5FA-211B-659B-08337049F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ECD882D-F59E-4D22-EE24-4986CBCAD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A581302-832E-148B-8816-1FCF7D71C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4801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C7ADC0C-DC47-0755-21ED-DD0FE5A8F4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BDBE731-ED0C-4D87-FF96-68EEDE123A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933AB4A-A9AA-381D-0754-4E25A714D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E809E3F-024B-A6DF-634F-017D6CFF3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CC79283-D1CD-7017-13FB-02E5A632E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DE0851A-DCB4-2928-518A-090588A86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4263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B346EC31-43C4-1429-37C1-48C24083E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B49F8E6-E2AB-8043-3210-B615E2B659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B02935C-9F8C-3742-7E0F-1D48A4D210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FCA2B3-2951-402C-925C-F9BB3D7AE8E4}" type="datetimeFigureOut">
              <a:rPr lang="it-IT" smtClean="0"/>
              <a:t>19/05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754CC80-3637-69BB-D960-08E9DE0334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C8DCD8C-AF14-6AAE-63DD-FA3548C40C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B42B2C-DA94-4B46-B28B-50FCC38862B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98363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6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5.emf"/><Relationship Id="rId4" Type="http://schemas.openxmlformats.org/officeDocument/2006/relationships/oleObject" Target="../embeddings/oleObject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ttangolo 10">
            <a:extLst>
              <a:ext uri="{FF2B5EF4-FFF2-40B4-BE49-F238E27FC236}">
                <a16:creationId xmlns:a16="http://schemas.microsoft.com/office/drawing/2014/main" id="{9F4BC0F8-2787-492B-FA61-D95BC50AA07B}"/>
              </a:ext>
            </a:extLst>
          </p:cNvPr>
          <p:cNvSpPr/>
          <p:nvPr/>
        </p:nvSpPr>
        <p:spPr>
          <a:xfrm>
            <a:off x="90435" y="160774"/>
            <a:ext cx="11987684" cy="49035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03E4EF4A-BBE5-8F14-F8A5-F1E8F4674A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0683908"/>
              </p:ext>
            </p:extLst>
          </p:nvPr>
        </p:nvGraphicFramePr>
        <p:xfrm>
          <a:off x="325577" y="622474"/>
          <a:ext cx="3743325" cy="3178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743885" imgH="3178821" progId="Prism8.Document">
                  <p:embed/>
                </p:oleObj>
              </mc:Choice>
              <mc:Fallback>
                <p:oleObj name="Prism 8" r:id="rId3" imgW="3743885" imgH="317882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5577" y="622474"/>
                        <a:ext cx="3743325" cy="3178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03A87F3E-BCD2-471C-2959-C0792E84F9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9821338"/>
              </p:ext>
            </p:extLst>
          </p:nvPr>
        </p:nvGraphicFramePr>
        <p:xfrm>
          <a:off x="4214288" y="622473"/>
          <a:ext cx="3743325" cy="3178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3743885" imgH="3178821" progId="Prism8.Document">
                  <p:embed/>
                </p:oleObj>
              </mc:Choice>
              <mc:Fallback>
                <p:oleObj name="Prism 8" r:id="rId5" imgW="3743885" imgH="317882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14288" y="622473"/>
                        <a:ext cx="3743325" cy="3178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7506FD17-2438-3D26-1908-6D9ED5B61C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7843323"/>
              </p:ext>
            </p:extLst>
          </p:nvPr>
        </p:nvGraphicFramePr>
        <p:xfrm>
          <a:off x="8102999" y="622473"/>
          <a:ext cx="3743325" cy="3178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743885" imgH="3178821" progId="Prism8.Document">
                  <p:embed/>
                </p:oleObj>
              </mc:Choice>
              <mc:Fallback>
                <p:oleObj name="Prism 8" r:id="rId7" imgW="3743885" imgH="317882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102999" y="622473"/>
                        <a:ext cx="3743325" cy="3178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606F69A2-491B-0A86-8308-0CE4AF72702F}"/>
              </a:ext>
            </a:extLst>
          </p:cNvPr>
          <p:cNvSpPr txBox="1"/>
          <p:nvPr/>
        </p:nvSpPr>
        <p:spPr>
          <a:xfrm>
            <a:off x="325577" y="4059534"/>
            <a:ext cx="1133051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 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-S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mericS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gG and anti-S nAbs in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rum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of PLWH. Data of anti-S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mericS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gG and anti-S nAbs are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tural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garithm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n). Panels A – C reported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rum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of PLWH which tested positive for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th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-S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mericS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gG and anti-S nAbs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ach time point: T1: n=31/75 (41.33%) (Panel A), T2: n=65/75 (86.66%) (Panel B); T3: n=71/75 (94.66%) (Panel C). 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96E714F-9149-B0D3-D9A9-27BFE982E9D6}"/>
              </a:ext>
            </a:extLst>
          </p:cNvPr>
          <p:cNvSpPr txBox="1"/>
          <p:nvPr/>
        </p:nvSpPr>
        <p:spPr>
          <a:xfrm>
            <a:off x="597720" y="43780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69DD0AAC-767F-CFE3-9606-144A38929E16}"/>
              </a:ext>
            </a:extLst>
          </p:cNvPr>
          <p:cNvSpPr txBox="1"/>
          <p:nvPr/>
        </p:nvSpPr>
        <p:spPr>
          <a:xfrm>
            <a:off x="4450503" y="43780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3C46C7AD-DFAE-F5AA-0135-EE72FE55E2B1}"/>
              </a:ext>
            </a:extLst>
          </p:cNvPr>
          <p:cNvSpPr txBox="1"/>
          <p:nvPr/>
        </p:nvSpPr>
        <p:spPr>
          <a:xfrm>
            <a:off x="8339214" y="43780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9240968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6D1479FE-33FC-63E0-3D19-18337C287C1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54806" y="1518180"/>
          <a:ext cx="2471737" cy="2668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471446" imgH="2668395" progId="Prism8.Document">
                  <p:embed/>
                </p:oleObj>
              </mc:Choice>
              <mc:Fallback>
                <p:oleObj name="Prism 8" r:id="rId2" imgW="2471446" imgH="2668395" progId="Prism8.Document">
                  <p:embed/>
                  <p:pic>
                    <p:nvPicPr>
                      <p:cNvPr id="4" name="Oggetto 3">
                        <a:extLst>
                          <a:ext uri="{FF2B5EF4-FFF2-40B4-BE49-F238E27FC236}">
                            <a16:creationId xmlns:a16="http://schemas.microsoft.com/office/drawing/2014/main" id="{6D1479FE-33FC-63E0-3D19-18337C287C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54806" y="1518180"/>
                        <a:ext cx="2471737" cy="2668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A9BBAAF6-15ED-65D3-3D79-6C472333DCA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26543" y="1564746"/>
          <a:ext cx="2471737" cy="2652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471446" imgH="2652917" progId="Prism8.Document">
                  <p:embed/>
                </p:oleObj>
              </mc:Choice>
              <mc:Fallback>
                <p:oleObj name="Prism 8" r:id="rId4" imgW="2471446" imgH="2652917" progId="Prism8.Document">
                  <p:embed/>
                  <p:pic>
                    <p:nvPicPr>
                      <p:cNvPr id="5" name="Oggetto 4">
                        <a:extLst>
                          <a:ext uri="{FF2B5EF4-FFF2-40B4-BE49-F238E27FC236}">
                            <a16:creationId xmlns:a16="http://schemas.microsoft.com/office/drawing/2014/main" id="{A9BBAAF6-15ED-65D3-3D79-6C472333DC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926543" y="1564746"/>
                        <a:ext cx="2471737" cy="2652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4B43E06C-1CFA-E2B4-4501-A13B7648B07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398280" y="1534054"/>
          <a:ext cx="2471737" cy="2652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2471446" imgH="2652917" progId="Prism8.Document">
                  <p:embed/>
                </p:oleObj>
              </mc:Choice>
              <mc:Fallback>
                <p:oleObj name="Prism 8" r:id="rId6" imgW="2471446" imgH="2652917" progId="Prism8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4B43E06C-1CFA-E2B4-4501-A13B7648B0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398280" y="1534054"/>
                        <a:ext cx="2471737" cy="2652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CB1C4F64-ECD2-DD1D-92DC-BEA18AAAB56E}"/>
              </a:ext>
            </a:extLst>
          </p:cNvPr>
          <p:cNvSpPr txBox="1"/>
          <p:nvPr/>
        </p:nvSpPr>
        <p:spPr>
          <a:xfrm>
            <a:off x="220134" y="4264025"/>
            <a:ext cx="11751733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71755" algn="just">
              <a:spcAft>
                <a:spcPts val="800"/>
              </a:spcAft>
              <a:buNone/>
            </a:pPr>
            <a:r>
              <a:rPr lang="en-US" sz="14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US" sz="14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xpression levels of IFN-I in PLWH receiving BNT162b2 COVID-19 vaccination in comparison to healthy donors (HD).</a:t>
            </a:r>
            <a:r>
              <a:rPr lang="en-US" sz="14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anels A-C represent expression levels of genes encoding IFN-α2 (A), IFN-β (B), IFN-ω (C) measured by RT-Real Time PCR, in PBMC collected from people living with HIV (PLWH) before the first administration of BNT162b2 vaccine (T0, n=66) in comparison to HD (n=48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or IFN-α2 and IFN-</a:t>
            </a:r>
            <a:r>
              <a:rPr lang="el-GR" sz="14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β</a:t>
            </a:r>
            <a:r>
              <a:rPr lang="it-IT" sz="14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; n=9 for IFN-ω)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Median values of gene expression levels are reported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400" kern="1200" baseline="30000" dirty="0">
                <a:solidFill>
                  <a:srgbClr val="000000"/>
                </a:solidFill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∗∗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&lt; 0.001; </a:t>
            </a:r>
            <a:r>
              <a:rPr lang="en-US" sz="1400" kern="1200" baseline="30000" dirty="0">
                <a:solidFill>
                  <a:srgbClr val="000000"/>
                </a:solidFill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∗∗∗</a:t>
            </a:r>
            <a:r>
              <a:rPr lang="en-US" sz="1400" baseline="30000" dirty="0">
                <a:solidFill>
                  <a:srgbClr val="000000"/>
                </a:solidFill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∗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&lt;0.0001. </a:t>
            </a:r>
            <a:endParaRPr lang="it-IT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977008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12</Words>
  <Application>Microsoft Office PowerPoint</Application>
  <PresentationFormat>Widescreen</PresentationFormat>
  <Paragraphs>6</Paragraphs>
  <Slides>2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9" baseType="lpstr">
      <vt:lpstr>Aptos</vt:lpstr>
      <vt:lpstr>Aptos Display</vt:lpstr>
      <vt:lpstr>Arial</vt:lpstr>
      <vt:lpstr>Cambria Math</vt:lpstr>
      <vt:lpstr>Times New Roman</vt:lpstr>
      <vt:lpstr>Tema di Office</vt:lpstr>
      <vt:lpstr>Prism 8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ederica Frasca</dc:creator>
  <cp:lastModifiedBy>Federica Frasca</cp:lastModifiedBy>
  <cp:revision>6</cp:revision>
  <dcterms:created xsi:type="dcterms:W3CDTF">2026-01-26T13:15:43Z</dcterms:created>
  <dcterms:modified xsi:type="dcterms:W3CDTF">2026-05-19T13:50:34Z</dcterms:modified>
</cp:coreProperties>
</file>